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5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72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genome.ucsc.edu/trash/hgt/hgt_genome_2d22_b34a70.png"/>
          <p:cNvPicPr>
            <a:picLocks noChangeAspect="1" noChangeArrowheads="1"/>
          </p:cNvPicPr>
          <p:nvPr/>
        </p:nvPicPr>
        <p:blipFill>
          <a:blip r:embed="rId2" cstate="print"/>
          <a:srcRect t="3364" b="70507"/>
          <a:stretch>
            <a:fillRect/>
          </a:stretch>
        </p:blipFill>
        <p:spPr bwMode="auto">
          <a:xfrm>
            <a:off x="1770530" y="138953"/>
            <a:ext cx="5221749" cy="5562479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</p:pic>
      <p:sp>
        <p:nvSpPr>
          <p:cNvPr id="5" name="Rectangle 4"/>
          <p:cNvSpPr/>
          <p:nvPr/>
        </p:nvSpPr>
        <p:spPr>
          <a:xfrm>
            <a:off x="2515945" y="265582"/>
            <a:ext cx="45719" cy="5435971"/>
          </a:xfrm>
          <a:prstGeom prst="rect">
            <a:avLst/>
          </a:prstGeom>
          <a:solidFill>
            <a:srgbClr val="FFC000">
              <a:alpha val="35000"/>
            </a:srgb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58122" y="5743125"/>
            <a:ext cx="778835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 Fig.  Conservation of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RP11-326A19.4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 UCSC browser snapshot of conserved regions spanning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RP11-326A19.4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 Conservation over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RP1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exons is restricted to mammals but varies with clades and species.  For instanc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1 is not found in most rodents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uarchontoglire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 but found in more distantly related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Afrotheri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 Exon 4 shows the highest conservation. The alternate TCONS forms (Human Body Map) reported exhibit less conservation in their last exon (red)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Rectangle 18"/>
          <p:cNvSpPr/>
          <p:nvPr/>
        </p:nvSpPr>
        <p:spPr>
          <a:xfrm rot="16200000">
            <a:off x="467544" y="3999759"/>
            <a:ext cx="13628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Laurasiatheria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 rot="16200000">
            <a:off x="515703" y="2116276"/>
            <a:ext cx="159152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Euarchontoglire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 rot="16200000">
            <a:off x="808157" y="5003287"/>
            <a:ext cx="63831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fro</a:t>
            </a:r>
          </a:p>
          <a:p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theri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Rectangle 21"/>
          <p:cNvSpPr/>
          <p:nvPr/>
        </p:nvSpPr>
        <p:spPr>
          <a:xfrm rot="16200000">
            <a:off x="865557" y="1495844"/>
            <a:ext cx="145584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rimates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411545" y="265582"/>
            <a:ext cx="45719" cy="5435971"/>
          </a:xfrm>
          <a:prstGeom prst="rect">
            <a:avLst/>
          </a:prstGeom>
          <a:solidFill>
            <a:srgbClr val="FFC000">
              <a:alpha val="35000"/>
            </a:srgb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929705" y="265582"/>
            <a:ext cx="45719" cy="5435971"/>
          </a:xfrm>
          <a:prstGeom prst="rect">
            <a:avLst/>
          </a:prstGeom>
          <a:solidFill>
            <a:srgbClr val="FFC000">
              <a:alpha val="35000"/>
            </a:srgb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6649795" y="265582"/>
            <a:ext cx="45719" cy="5435971"/>
          </a:xfrm>
          <a:prstGeom prst="rect">
            <a:avLst/>
          </a:prstGeom>
          <a:solidFill>
            <a:srgbClr val="FFC000">
              <a:alpha val="35000"/>
            </a:srgb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 rot="16200000">
            <a:off x="1169829" y="2543064"/>
            <a:ext cx="84730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odents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1720850" y="2419350"/>
            <a:ext cx="0" cy="6477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720850" y="1574800"/>
            <a:ext cx="0" cy="7493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1263650" y="3346450"/>
            <a:ext cx="40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H="1">
            <a:off x="1263650" y="1581150"/>
            <a:ext cx="40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H="1">
            <a:off x="1263650" y="5048250"/>
            <a:ext cx="40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>
            <a:off x="1263650" y="5505450"/>
            <a:ext cx="40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6355081" y="265582"/>
            <a:ext cx="45719" cy="5435971"/>
          </a:xfrm>
          <a:prstGeom prst="rect">
            <a:avLst/>
          </a:prstGeom>
          <a:solidFill>
            <a:srgbClr val="FF0000">
              <a:alpha val="35000"/>
            </a:srgb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3922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8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8:09Z</dcterms:modified>
</cp:coreProperties>
</file>